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wmf" ContentType="image/x-wmf"/>
  <Override PartName="/ppt/media/image4.wmf" ContentType="image/x-wmf"/>
  <Override PartName="/ppt/media/image5.wmf" ContentType="image/x-wmf"/>
  <Override PartName="/ppt/media/image7.jpeg" ContentType="image/jpeg"/>
  <Override PartName="/ppt/media/image6.wmf" ContentType="image/x-wmf"/>
  <Override PartName="/ppt/embeddings/oleObject1.docx" ContentType="application/vnd.openxmlformats-officedocument.wordprocessingml.document"/>
  <Override PartName="/ppt/presProps.xml" ContentType="application/vnd.openxmlformats-officedocument.presentationml.presProps+xml"/>
  <Override PartName="/ppt/slides/_rels/slide12.xml.rels" ContentType="application/vnd.openxmlformats-package.relationships+xml"/>
  <Override PartName="/ppt/slides/_rels/slide13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7.xml.rels" ContentType="application/vnd.openxmlformats-package.relationships+xml"/>
  <Override PartName="/ppt/slides/_rels/slide10.xml.rels" ContentType="application/vnd.openxmlformats-package.relationships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5839EC-60C8-4D4B-8478-D754C47BB24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1371600" y="3962160"/>
            <a:ext cx="685800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/>
          </p:nvPr>
        </p:nvSpPr>
        <p:spPr>
          <a:xfrm>
            <a:off x="1371600" y="4798080"/>
            <a:ext cx="685800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D3172A-910B-465C-A0D1-37FA91B1A9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1371600" y="396216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4885920" y="396216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1371600" y="479808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4885920" y="479808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CF6FA3-D9AD-49D2-A9C6-54B7D270504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/>
          </p:nvPr>
        </p:nvSpPr>
        <p:spPr>
          <a:xfrm>
            <a:off x="1371600" y="3962160"/>
            <a:ext cx="220788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9000"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3"/>
          <p:cNvSpPr>
            <a:spLocks noGrp="1"/>
          </p:cNvSpPr>
          <p:nvPr>
            <p:ph/>
          </p:nvPr>
        </p:nvSpPr>
        <p:spPr>
          <a:xfrm>
            <a:off x="3690360" y="3962160"/>
            <a:ext cx="220788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9000"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4"/>
          <p:cNvSpPr>
            <a:spLocks noGrp="1"/>
          </p:cNvSpPr>
          <p:nvPr>
            <p:ph/>
          </p:nvPr>
        </p:nvSpPr>
        <p:spPr>
          <a:xfrm>
            <a:off x="6008760" y="3962160"/>
            <a:ext cx="220788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9000"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5"/>
          <p:cNvSpPr>
            <a:spLocks noGrp="1"/>
          </p:cNvSpPr>
          <p:nvPr>
            <p:ph/>
          </p:nvPr>
        </p:nvSpPr>
        <p:spPr>
          <a:xfrm>
            <a:off x="1371600" y="4798080"/>
            <a:ext cx="220788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9000"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6"/>
          <p:cNvSpPr>
            <a:spLocks noGrp="1"/>
          </p:cNvSpPr>
          <p:nvPr>
            <p:ph/>
          </p:nvPr>
        </p:nvSpPr>
        <p:spPr>
          <a:xfrm>
            <a:off x="3690360" y="4798080"/>
            <a:ext cx="220788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9000"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7"/>
          <p:cNvSpPr>
            <a:spLocks noGrp="1"/>
          </p:cNvSpPr>
          <p:nvPr>
            <p:ph/>
          </p:nvPr>
        </p:nvSpPr>
        <p:spPr>
          <a:xfrm>
            <a:off x="6008760" y="4798080"/>
            <a:ext cx="220788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9000"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05D661-C058-4326-8ED3-A70D67C0D80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95C8EE3-6749-439E-80DF-4A87797A940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 type="subTitle"/>
          </p:nvPr>
        </p:nvSpPr>
        <p:spPr>
          <a:xfrm>
            <a:off x="1371600" y="3962160"/>
            <a:ext cx="6858000" cy="160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ECA1A48-2DFA-43E3-8430-4B37F6FC39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1371600" y="3962160"/>
            <a:ext cx="6858000" cy="160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21C09FC-0A39-40D0-93F3-9575AAF164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1371600" y="3962160"/>
            <a:ext cx="3346560" cy="160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PlaceHolder 3"/>
          <p:cNvSpPr>
            <a:spLocks noGrp="1"/>
          </p:cNvSpPr>
          <p:nvPr>
            <p:ph/>
          </p:nvPr>
        </p:nvSpPr>
        <p:spPr>
          <a:xfrm>
            <a:off x="4885920" y="3962160"/>
            <a:ext cx="3346560" cy="160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DBE6EC0-F585-46A2-B3C1-83623351A5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94DDA79-56A6-4643-8E08-C53ABF883F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subTitle"/>
          </p:nvPr>
        </p:nvSpPr>
        <p:spPr>
          <a:xfrm>
            <a:off x="2057040" y="1143000"/>
            <a:ext cx="6629400" cy="10244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4A79997-A45D-461A-8A9A-60BAF1F644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1371600" y="396216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885920" y="3962160"/>
            <a:ext cx="3346560" cy="160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1371600" y="479808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300CA06-B700-49B3-B19D-79826541BF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subTitle"/>
          </p:nvPr>
        </p:nvSpPr>
        <p:spPr>
          <a:xfrm>
            <a:off x="1371600" y="3962160"/>
            <a:ext cx="6858000" cy="160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7A0AA9-CE93-4D1F-9213-0B2E528EB8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75" name="PlaceHolder 2"/>
          <p:cNvSpPr>
            <a:spLocks noGrp="1"/>
          </p:cNvSpPr>
          <p:nvPr>
            <p:ph/>
          </p:nvPr>
        </p:nvSpPr>
        <p:spPr>
          <a:xfrm>
            <a:off x="1371600" y="3962160"/>
            <a:ext cx="3346560" cy="160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3"/>
          <p:cNvSpPr>
            <a:spLocks noGrp="1"/>
          </p:cNvSpPr>
          <p:nvPr>
            <p:ph/>
          </p:nvPr>
        </p:nvSpPr>
        <p:spPr>
          <a:xfrm>
            <a:off x="4885920" y="396216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4"/>
          <p:cNvSpPr>
            <a:spLocks noGrp="1"/>
          </p:cNvSpPr>
          <p:nvPr>
            <p:ph/>
          </p:nvPr>
        </p:nvSpPr>
        <p:spPr>
          <a:xfrm>
            <a:off x="4885920" y="479808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DCE15FA-44E5-4544-8DFC-39FA599566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79" name="PlaceHolder 2"/>
          <p:cNvSpPr>
            <a:spLocks noGrp="1"/>
          </p:cNvSpPr>
          <p:nvPr>
            <p:ph/>
          </p:nvPr>
        </p:nvSpPr>
        <p:spPr>
          <a:xfrm>
            <a:off x="1371600" y="396216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3"/>
          <p:cNvSpPr>
            <a:spLocks noGrp="1"/>
          </p:cNvSpPr>
          <p:nvPr>
            <p:ph/>
          </p:nvPr>
        </p:nvSpPr>
        <p:spPr>
          <a:xfrm>
            <a:off x="4885920" y="396216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4"/>
          <p:cNvSpPr>
            <a:spLocks noGrp="1"/>
          </p:cNvSpPr>
          <p:nvPr>
            <p:ph/>
          </p:nvPr>
        </p:nvSpPr>
        <p:spPr>
          <a:xfrm>
            <a:off x="1371600" y="4798080"/>
            <a:ext cx="685800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5A05C41-D0B7-4C5A-BB83-A4C3EA8074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/>
          </p:nvPr>
        </p:nvSpPr>
        <p:spPr>
          <a:xfrm>
            <a:off x="1371600" y="3962160"/>
            <a:ext cx="685800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/>
          </p:nvPr>
        </p:nvSpPr>
        <p:spPr>
          <a:xfrm>
            <a:off x="1371600" y="4798080"/>
            <a:ext cx="685800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ABBFBC7-2F07-450D-AD2C-348913FCF5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/>
          </p:nvPr>
        </p:nvSpPr>
        <p:spPr>
          <a:xfrm>
            <a:off x="1371600" y="396216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PlaceHolder 3"/>
          <p:cNvSpPr>
            <a:spLocks noGrp="1"/>
          </p:cNvSpPr>
          <p:nvPr>
            <p:ph/>
          </p:nvPr>
        </p:nvSpPr>
        <p:spPr>
          <a:xfrm>
            <a:off x="4885920" y="396216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4"/>
          <p:cNvSpPr>
            <a:spLocks noGrp="1"/>
          </p:cNvSpPr>
          <p:nvPr>
            <p:ph/>
          </p:nvPr>
        </p:nvSpPr>
        <p:spPr>
          <a:xfrm>
            <a:off x="1371600" y="479808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PlaceHolder 5"/>
          <p:cNvSpPr>
            <a:spLocks noGrp="1"/>
          </p:cNvSpPr>
          <p:nvPr>
            <p:ph/>
          </p:nvPr>
        </p:nvSpPr>
        <p:spPr>
          <a:xfrm>
            <a:off x="4885920" y="479808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17BC720-155D-4418-AA6C-88200AAFF28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/>
          </p:nvPr>
        </p:nvSpPr>
        <p:spPr>
          <a:xfrm>
            <a:off x="1371600" y="3962160"/>
            <a:ext cx="220788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9000"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3"/>
          <p:cNvSpPr>
            <a:spLocks noGrp="1"/>
          </p:cNvSpPr>
          <p:nvPr>
            <p:ph/>
          </p:nvPr>
        </p:nvSpPr>
        <p:spPr>
          <a:xfrm>
            <a:off x="3690360" y="3962160"/>
            <a:ext cx="220788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9000"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4"/>
          <p:cNvSpPr>
            <a:spLocks noGrp="1"/>
          </p:cNvSpPr>
          <p:nvPr>
            <p:ph/>
          </p:nvPr>
        </p:nvSpPr>
        <p:spPr>
          <a:xfrm>
            <a:off x="6008760" y="3962160"/>
            <a:ext cx="220788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9000"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PlaceHolder 5"/>
          <p:cNvSpPr>
            <a:spLocks noGrp="1"/>
          </p:cNvSpPr>
          <p:nvPr>
            <p:ph/>
          </p:nvPr>
        </p:nvSpPr>
        <p:spPr>
          <a:xfrm>
            <a:off x="1371600" y="4798080"/>
            <a:ext cx="220788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9000"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PlaceHolder 6"/>
          <p:cNvSpPr>
            <a:spLocks noGrp="1"/>
          </p:cNvSpPr>
          <p:nvPr>
            <p:ph/>
          </p:nvPr>
        </p:nvSpPr>
        <p:spPr>
          <a:xfrm>
            <a:off x="3690360" y="4798080"/>
            <a:ext cx="220788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9000"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PlaceHolder 7"/>
          <p:cNvSpPr>
            <a:spLocks noGrp="1"/>
          </p:cNvSpPr>
          <p:nvPr>
            <p:ph/>
          </p:nvPr>
        </p:nvSpPr>
        <p:spPr>
          <a:xfrm>
            <a:off x="6008760" y="4798080"/>
            <a:ext cx="220788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 fontScale="89000"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FF629D5-0F43-4F92-BD7F-7DC2782F3D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1371600" y="3962160"/>
            <a:ext cx="6858000" cy="160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B7440B-817E-4CB5-9174-A04DD344DE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1371600" y="3962160"/>
            <a:ext cx="3346560" cy="160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885920" y="3962160"/>
            <a:ext cx="3346560" cy="160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35061F-1801-4538-8436-F438FE72A3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D6AB5C-56CB-42AA-B42D-A1C3160350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subTitle"/>
          </p:nvPr>
        </p:nvSpPr>
        <p:spPr>
          <a:xfrm>
            <a:off x="2057040" y="1143000"/>
            <a:ext cx="6629400" cy="10244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B8669A-2FD4-4012-A44C-16BBCD8702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1371600" y="396216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/>
          </p:nvPr>
        </p:nvSpPr>
        <p:spPr>
          <a:xfrm>
            <a:off x="4885920" y="3962160"/>
            <a:ext cx="3346560" cy="160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/>
          </p:nvPr>
        </p:nvSpPr>
        <p:spPr>
          <a:xfrm>
            <a:off x="1371600" y="479808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75C9B1-DAFB-422A-92C4-1A2745254D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1371600" y="3962160"/>
            <a:ext cx="3346560" cy="1600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4885920" y="396216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4"/>
          <p:cNvSpPr>
            <a:spLocks noGrp="1"/>
          </p:cNvSpPr>
          <p:nvPr>
            <p:ph/>
          </p:nvPr>
        </p:nvSpPr>
        <p:spPr>
          <a:xfrm>
            <a:off x="4885920" y="479808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AF559E-38C1-4BA6-AE8D-66821A5220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/>
          </p:nvPr>
        </p:nvSpPr>
        <p:spPr>
          <a:xfrm>
            <a:off x="1371600" y="396216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/>
          </p:nvPr>
        </p:nvSpPr>
        <p:spPr>
          <a:xfrm>
            <a:off x="4885920" y="3962160"/>
            <a:ext cx="334656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4"/>
          <p:cNvSpPr>
            <a:spLocks noGrp="1"/>
          </p:cNvSpPr>
          <p:nvPr>
            <p:ph/>
          </p:nvPr>
        </p:nvSpPr>
        <p:spPr>
          <a:xfrm>
            <a:off x="1371600" y="4798080"/>
            <a:ext cx="6858000" cy="76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96BCA9-B584-42A2-B27D-1EEED404D1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e1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0" name=""/>
          <p:cNvGrpSpPr/>
          <p:nvPr/>
        </p:nvGrpSpPr>
        <p:grpSpPr>
          <a:xfrm>
            <a:off x="0" y="0"/>
            <a:ext cx="8686800" cy="4876920"/>
            <a:chOff x="0" y="0"/>
            <a:chExt cx="8686800" cy="4876920"/>
          </a:xfrm>
        </p:grpSpPr>
        <p:sp>
          <p:nvSpPr>
            <p:cNvPr id="1" name=""/>
            <p:cNvSpPr/>
            <p:nvPr/>
          </p:nvSpPr>
          <p:spPr>
            <a:xfrm>
              <a:off x="0" y="0"/>
              <a:ext cx="609480" cy="4876920"/>
            </a:xfrm>
            <a:prstGeom prst="rect">
              <a:avLst/>
            </a:prstGeom>
            <a:solidFill>
              <a:srgbClr val="cc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" name=""/>
            <p:cNvGrpSpPr/>
            <p:nvPr/>
          </p:nvGrpSpPr>
          <p:grpSpPr>
            <a:xfrm>
              <a:off x="380880" y="1417680"/>
              <a:ext cx="8305920" cy="182520"/>
              <a:chOff x="380880" y="1417680"/>
              <a:chExt cx="8305920" cy="182520"/>
            </a:xfrm>
          </p:grpSpPr>
          <p:sp>
            <p:nvSpPr>
              <p:cNvPr id="3" name=""/>
              <p:cNvSpPr/>
              <p:nvPr/>
            </p:nvSpPr>
            <p:spPr>
              <a:xfrm>
                <a:off x="6858000" y="1417680"/>
                <a:ext cx="1828800" cy="182520"/>
              </a:xfrm>
              <a:prstGeom prst="rect">
                <a:avLst/>
              </a:prstGeom>
              <a:solidFill>
                <a:srgbClr val="b2b2b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" name=""/>
              <p:cNvSpPr/>
              <p:nvPr/>
            </p:nvSpPr>
            <p:spPr>
              <a:xfrm>
                <a:off x="380880" y="1494000"/>
                <a:ext cx="8305920" cy="0"/>
              </a:xfrm>
              <a:prstGeom prst="line">
                <a:avLst/>
              </a:prstGeom>
              <a:ln w="19080">
                <a:solidFill>
                  <a:srgbClr val="3300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914400" y="27756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330033"/>
                </a:solidFill>
                <a:latin typeface="Times New Roman"/>
              </a:rPr>
              <a:t>Click to edit the title text format</a:t>
            </a:r>
            <a:endParaRPr b="0" lang="en-US" sz="42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914400" y="1599840"/>
            <a:ext cx="777240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00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00"/>
              </a:spcBef>
              <a:buClr>
                <a:srgbClr val="b2b2b2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00"/>
              </a:spcBef>
              <a:buClr>
                <a:srgbClr val="cccc99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00"/>
              </a:spcBef>
              <a:buClr>
                <a:srgbClr val="cccc99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00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00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3"/>
          <p:cNvSpPr>
            <a:spLocks noGrp="1"/>
          </p:cNvSpPr>
          <p:nvPr>
            <p:ph type="dt" idx="1"/>
          </p:nvPr>
        </p:nvSpPr>
        <p:spPr>
          <a:xfrm>
            <a:off x="914040" y="6251400"/>
            <a:ext cx="19810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0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4"/>
          <p:cNvSpPr>
            <a:spLocks noGrp="1"/>
          </p:cNvSpPr>
          <p:nvPr>
            <p:ph type="ftr" idx="2"/>
          </p:nvPr>
        </p:nvSpPr>
        <p:spPr>
          <a:xfrm>
            <a:off x="3352320" y="624852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0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5"/>
          <p:cNvSpPr>
            <a:spLocks noGrp="1"/>
          </p:cNvSpPr>
          <p:nvPr>
            <p:ph type="sldNum" idx="3"/>
          </p:nvPr>
        </p:nvSpPr>
        <p:spPr>
          <a:xfrm>
            <a:off x="67816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0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E7EBF9-DBBE-46A7-8129-D7E334F1C07D}" type="slidenum">
              <a:rPr b="0" lang="es-ES_tradnl" sz="10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"/>
          <p:cNvSpPr/>
          <p:nvPr/>
        </p:nvSpPr>
        <p:spPr>
          <a:xfrm>
            <a:off x="0" y="4876920"/>
            <a:ext cx="609480" cy="0"/>
          </a:xfrm>
          <a:prstGeom prst="line">
            <a:avLst/>
          </a:prstGeom>
          <a:ln w="44280">
            <a:solidFill>
              <a:srgbClr val="3300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e1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"/>
          <p:cNvGrpSpPr/>
          <p:nvPr/>
        </p:nvGrpSpPr>
        <p:grpSpPr>
          <a:xfrm>
            <a:off x="0" y="0"/>
            <a:ext cx="8763120" cy="5943600"/>
            <a:chOff x="0" y="0"/>
            <a:chExt cx="8763120" cy="5943600"/>
          </a:xfrm>
        </p:grpSpPr>
        <p:sp>
          <p:nvSpPr>
            <p:cNvPr id="48" name=""/>
            <p:cNvSpPr/>
            <p:nvPr/>
          </p:nvSpPr>
          <p:spPr>
            <a:xfrm>
              <a:off x="0" y="0"/>
              <a:ext cx="1752480" cy="4876920"/>
            </a:xfrm>
            <a:prstGeom prst="rect">
              <a:avLst/>
            </a:prstGeom>
            <a:solidFill>
              <a:srgbClr val="cccc9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9" name=""/>
            <p:cNvGrpSpPr/>
            <p:nvPr/>
          </p:nvGrpSpPr>
          <p:grpSpPr>
            <a:xfrm>
              <a:off x="0" y="3505320"/>
              <a:ext cx="8763120" cy="2438280"/>
              <a:chOff x="0" y="3505320"/>
              <a:chExt cx="8763120" cy="2438280"/>
            </a:xfrm>
          </p:grpSpPr>
          <p:sp>
            <p:nvSpPr>
              <p:cNvPr id="50" name=""/>
              <p:cNvSpPr/>
              <p:nvPr/>
            </p:nvSpPr>
            <p:spPr>
              <a:xfrm>
                <a:off x="990720" y="3505320"/>
                <a:ext cx="7772400" cy="2438280"/>
              </a:xfrm>
              <a:prstGeom prst="rect">
                <a:avLst/>
              </a:prstGeom>
              <a:solidFill>
                <a:srgbClr val="330033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1038240" y="3733920"/>
                <a:ext cx="7648560" cy="2138400"/>
              </a:xfrm>
              <a:prstGeom prst="rect">
                <a:avLst/>
              </a:prstGeom>
              <a:solidFill>
                <a:srgbClr val="ffff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0" y="4876920"/>
                <a:ext cx="990720" cy="0"/>
              </a:xfrm>
              <a:prstGeom prst="line">
                <a:avLst/>
              </a:prstGeom>
              <a:ln w="50760">
                <a:solidFill>
                  <a:srgbClr val="3300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3" name=""/>
            <p:cNvGrpSpPr/>
            <p:nvPr/>
          </p:nvGrpSpPr>
          <p:grpSpPr>
            <a:xfrm>
              <a:off x="635040" y="533520"/>
              <a:ext cx="8077320" cy="304560"/>
              <a:chOff x="635040" y="533520"/>
              <a:chExt cx="8077320" cy="304560"/>
            </a:xfrm>
          </p:grpSpPr>
          <p:sp>
            <p:nvSpPr>
              <p:cNvPr id="54" name=""/>
              <p:cNvSpPr/>
              <p:nvPr/>
            </p:nvSpPr>
            <p:spPr>
              <a:xfrm>
                <a:off x="6273720" y="533520"/>
                <a:ext cx="2438640" cy="304560"/>
              </a:xfrm>
              <a:prstGeom prst="rect">
                <a:avLst/>
              </a:prstGeom>
              <a:solidFill>
                <a:srgbClr val="b2b2b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635040" y="685800"/>
                <a:ext cx="8077320" cy="0"/>
              </a:xfrm>
              <a:prstGeom prst="line">
                <a:avLst/>
              </a:prstGeom>
              <a:ln w="44280">
                <a:solidFill>
                  <a:srgbClr val="330033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2057040" y="1143000"/>
            <a:ext cx="6629400" cy="2209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330033"/>
                </a:solidFill>
                <a:latin typeface="Times New Roman"/>
              </a:rPr>
              <a:t>Click to edit the title text format</a:t>
            </a:r>
            <a:endParaRPr b="0" lang="en-US" sz="48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 type="dt" idx="4"/>
          </p:nvPr>
        </p:nvSpPr>
        <p:spPr>
          <a:xfrm>
            <a:off x="912600" y="6251400"/>
            <a:ext cx="190476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0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PlaceHolder 3"/>
          <p:cNvSpPr>
            <a:spLocks noGrp="1"/>
          </p:cNvSpPr>
          <p:nvPr>
            <p:ph type="ftr" idx="5"/>
          </p:nvPr>
        </p:nvSpPr>
        <p:spPr>
          <a:xfrm>
            <a:off x="3354120" y="6248520"/>
            <a:ext cx="28954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0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10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PlaceHolder 4"/>
          <p:cNvSpPr>
            <a:spLocks noGrp="1"/>
          </p:cNvSpPr>
          <p:nvPr>
            <p:ph type="sldNum" idx="6"/>
          </p:nvPr>
        </p:nvSpPr>
        <p:spPr>
          <a:xfrm>
            <a:off x="67816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0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68BEFF-9974-4074-A7FE-D994C3246945}" type="slidenum">
              <a:rPr b="0" lang="es-ES_tradnl" sz="10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0" algn="ctr">
              <a:spcBef>
                <a:spcPts val="6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2" marL="914400" algn="ctr">
              <a:spcBef>
                <a:spcPts val="575"/>
              </a:spcBef>
              <a:buClr>
                <a:srgbClr val="b2b2b2"/>
              </a:buClr>
              <a:buSzPct val="55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  <a:p>
            <a:pPr lvl="3" marL="1371600" algn="ctr">
              <a:spcBef>
                <a:spcPts val="499"/>
              </a:spcBef>
              <a:buClr>
                <a:srgbClr val="cccc99"/>
              </a:buClr>
              <a:buFont typeface="Wingdings" charset="2"/>
              <a:buChar char="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1828800" algn="ctr">
              <a:spcBef>
                <a:spcPts val="499"/>
              </a:spcBef>
              <a:buClr>
                <a:srgbClr val="cccc99"/>
              </a:buClr>
              <a:buFont typeface="Wingdings" charset="2"/>
              <a:buChar char=""/>
              <a:tabLst>
                <a:tab algn="l" pos="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18288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1828800">
              <a:spcBef>
                <a:spcPts val="499"/>
              </a:spcBef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mailto:mvallejo@psi.uned.es" TargetMode="External"/><Relationship Id="rId2" Type="http://schemas.openxmlformats.org/officeDocument/2006/relationships/hyperlink" Target="mailto:mvallejo@psi.uned.es" TargetMode="External"/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slideLayout" Target="../slideLayouts/slideLayout14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4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7.jpeg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4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4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4.wmf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5.wmf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6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e1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684360" y="1628640"/>
            <a:ext cx="7772400" cy="1727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330033"/>
                </a:solidFill>
                <a:latin typeface="Baskerville Old Face"/>
              </a:rPr>
              <a:t>Psychological assessment through the Internet</a:t>
            </a:r>
            <a:endParaRPr b="0" lang="en-US" sz="40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98" name="PlaceHolder 2"/>
          <p:cNvSpPr>
            <a:spLocks noGrp="1"/>
          </p:cNvSpPr>
          <p:nvPr>
            <p:ph type="subTitle"/>
          </p:nvPr>
        </p:nvSpPr>
        <p:spPr>
          <a:xfrm>
            <a:off x="1619280" y="4508280"/>
            <a:ext cx="6400800" cy="1368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A reliability and validity study of online (vs. paper-and-pencil) versions of the General Health Questionnaire-28 (GHQ-28) and the Symptoms Check-List-90-R (SCL-90-R) 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1222200" y="3068640"/>
            <a:ext cx="792180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1547640" y="189000"/>
            <a:ext cx="713124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3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2200" spc="-1" strike="noStrike">
                <a:solidFill>
                  <a:srgbClr val="5f5f5f"/>
                </a:solidFill>
                <a:latin typeface="Baskerville Old Face"/>
              </a:rPr>
              <a:t>Universidad Nacional de Educación a Distancia, SPAIN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1042920" y="3933720"/>
            <a:ext cx="7777080" cy="44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2000" spc="-1" strike="noStrike" u="sng">
                <a:solidFill>
                  <a:srgbClr val="990033"/>
                </a:solidFill>
                <a:uFillTx/>
                <a:latin typeface="Baskerville Old Face"/>
                <a:hlinkClick r:id="rId1"/>
              </a:rPr>
              <a:t>M.A</a:t>
            </a:r>
            <a:r>
              <a:rPr b="0" lang="es-ES" sz="2000" spc="-1" strike="noStrike" u="sng">
                <a:solidFill>
                  <a:srgbClr val="990033"/>
                </a:solidFill>
                <a:uFillTx/>
                <a:latin typeface="Baskerville Old Face"/>
                <a:hlinkClick r:id="rId2"/>
              </a:rPr>
              <a:t>. Vallejo</a:t>
            </a:r>
            <a:r>
              <a:rPr b="1" lang="es-ES" sz="2000" spc="-1" strike="noStrike">
                <a:solidFill>
                  <a:srgbClr val="000000"/>
                </a:solidFill>
                <a:latin typeface="Baskerville Old Face"/>
              </a:rPr>
              <a:t>, C.M. Jordán, M.I. Díaz, M.I. Comeche &amp; J. Orteg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2" name="" descr=""/>
          <p:cNvPicPr/>
          <p:nvPr/>
        </p:nvPicPr>
        <p:blipFill>
          <a:blip r:embed="rId3"/>
          <a:stretch/>
        </p:blipFill>
        <p:spPr>
          <a:xfrm>
            <a:off x="7885080" y="836640"/>
            <a:ext cx="827280" cy="826920"/>
          </a:xfrm>
          <a:prstGeom prst="rect">
            <a:avLst/>
          </a:prstGeom>
          <a:ln w="0">
            <a:noFill/>
          </a:ln>
        </p:spPr>
      </p:pic>
      <p:pic>
        <p:nvPicPr>
          <p:cNvPr id="103" name="" descr=""/>
          <p:cNvPicPr/>
          <p:nvPr/>
        </p:nvPicPr>
        <p:blipFill>
          <a:blip r:embed="rId4"/>
          <a:stretch/>
        </p:blipFill>
        <p:spPr>
          <a:xfrm>
            <a:off x="611280" y="836640"/>
            <a:ext cx="1866960" cy="714240"/>
          </a:xfrm>
          <a:prstGeom prst="rect">
            <a:avLst/>
          </a:prstGeom>
          <a:ln w="0">
            <a:noFill/>
          </a:ln>
        </p:spPr>
      </p:pic>
      <p:sp>
        <p:nvSpPr>
          <p:cNvPr id="104" name=""/>
          <p:cNvSpPr/>
          <p:nvPr/>
        </p:nvSpPr>
        <p:spPr>
          <a:xfrm>
            <a:off x="1332000" y="6165720"/>
            <a:ext cx="7200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000" spc="-1" strike="noStrike">
                <a:solidFill>
                  <a:srgbClr val="330033"/>
                </a:solidFill>
                <a:latin typeface="Baskerville Old Face"/>
              </a:rPr>
              <a:t>* Paper presented at the Second Meeting of the International Society for Research on Internet Interventions. April 28-29, 2006 Karolinska Institute Stockholm, Sweden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spd="slow">
    <p:pull dir="lu"/>
  </p:transition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e1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914400" y="27756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330033"/>
                </a:solidFill>
                <a:latin typeface="Baskerville Old Face"/>
              </a:rPr>
              <a:t>SCL-90-R factorial structure</a:t>
            </a:r>
            <a:endParaRPr b="0" lang="en-US" sz="42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128" name="PlaceHolder 2"/>
          <p:cNvSpPr>
            <a:spLocks noGrp="1"/>
          </p:cNvSpPr>
          <p:nvPr>
            <p:ph/>
          </p:nvPr>
        </p:nvSpPr>
        <p:spPr>
          <a:xfrm>
            <a:off x="900000" y="2327040"/>
            <a:ext cx="777240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0000"/>
              </a:lnSpc>
              <a:spcBef>
                <a:spcPts val="700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We failed to replicate the 9 factors original structur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spcBef>
                <a:spcPts val="700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Instead a big unrotated factor that explained more that 25% of the variance appeared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spcBef>
                <a:spcPts val="700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85 out 90 items showed .30 or bigger loads on this factor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spd="slow">
    <p:pull dir="lu"/>
  </p:transition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e1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PlaceHolder 1"/>
          <p:cNvSpPr>
            <a:spLocks noGrp="1"/>
          </p:cNvSpPr>
          <p:nvPr>
            <p:ph type="title"/>
          </p:nvPr>
        </p:nvSpPr>
        <p:spPr>
          <a:xfrm>
            <a:off x="914400" y="27756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330033"/>
                </a:solidFill>
                <a:latin typeface="Baskerville Old Face"/>
              </a:rPr>
              <a:t>Discussion</a:t>
            </a:r>
            <a:endParaRPr b="0" lang="en-US" sz="42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130" name="PlaceHolder 2"/>
          <p:cNvSpPr>
            <a:spLocks noGrp="1"/>
          </p:cNvSpPr>
          <p:nvPr>
            <p:ph/>
          </p:nvPr>
        </p:nvSpPr>
        <p:spPr>
          <a:xfrm>
            <a:off x="900000" y="1699920"/>
            <a:ext cx="381024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8000"/>
          </a:bodyPr>
          <a:p>
            <a:pPr marL="335880" indent="-33588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GHQ-28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27920" indent="-280080">
              <a:lnSpc>
                <a:spcPct val="90000"/>
              </a:lnSpc>
              <a:spcBef>
                <a:spcPts val="601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High internal consistency (all 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  <a:ea typeface="Arial"/>
              </a:rPr>
              <a:t>α ≥ .78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27920" indent="-280080">
              <a:lnSpc>
                <a:spcPct val="90000"/>
              </a:lnSpc>
              <a:spcBef>
                <a:spcPts val="601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askerville Old Face"/>
                <a:ea typeface="Arial"/>
              </a:rPr>
              <a:t>Equivalence data smaller than expected in scales A (r = .53) and C (r = .30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27920" indent="-280080">
              <a:lnSpc>
                <a:spcPct val="90000"/>
              </a:lnSpc>
              <a:spcBef>
                <a:spcPts val="601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askerville Old Face"/>
                <a:ea typeface="Arial"/>
              </a:rPr>
              <a:t>Fairly good factorial validity. Scales C and D were more consistent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3"/>
          <p:cNvSpPr>
            <a:spLocks noGrp="1"/>
          </p:cNvSpPr>
          <p:nvPr>
            <p:ph/>
          </p:nvPr>
        </p:nvSpPr>
        <p:spPr>
          <a:xfrm>
            <a:off x="4859280" y="1699920"/>
            <a:ext cx="3943440" cy="453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9000"/>
          </a:bodyPr>
          <a:p>
            <a:pPr marL="305280" indent="-305280">
              <a:lnSpc>
                <a:spcPct val="90000"/>
              </a:lnSpc>
              <a:spcBef>
                <a:spcPts val="601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SCL-90-R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660960" indent="-254160">
              <a:lnSpc>
                <a:spcPct val="90000"/>
              </a:lnSpc>
              <a:spcBef>
                <a:spcPts val="601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High internal consistency (all 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  <a:ea typeface="Arial"/>
              </a:rPr>
              <a:t>α ≥ .72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660960" indent="-254160">
              <a:lnSpc>
                <a:spcPct val="90000"/>
              </a:lnSpc>
              <a:spcBef>
                <a:spcPts val="601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askerville Old Face"/>
                <a:ea typeface="Arial"/>
              </a:rPr>
              <a:t>Correlations supports the equivalence hypothesis (r = .63 - .86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660960" indent="-254160">
              <a:lnSpc>
                <a:spcPct val="90000"/>
              </a:lnSpc>
              <a:spcBef>
                <a:spcPts val="601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askerville Old Face"/>
                <a:ea typeface="Arial"/>
              </a:rPr>
              <a:t>Mean differences in ‘somatization’ and ‘GSI’ could be taken as a small effect of a treatmen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660960" indent="-254160">
              <a:lnSpc>
                <a:spcPct val="90000"/>
              </a:lnSpc>
              <a:spcBef>
                <a:spcPts val="601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askerville Old Face"/>
                <a:ea typeface="Arial"/>
              </a:rPr>
              <a:t>A single factor structure appeared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spd="slow">
    <p:pull dir="lu"/>
  </p:transition>
  <p:timing>
    <p:tnLst>
      <p:par>
        <p:cTn id="61" dur="indefinite" restart="never" nodeType="tmRoot">
          <p:childTnLst>
            <p:seq>
              <p:cTn id="62" dur="indefinite" nodeType="mainSeq">
                <p:childTnLst>
                  <p:par>
                    <p:cTn id="63" fill="hold">
                      <p:stCondLst>
                        <p:cond delay="indefinite"/>
                      </p:stCondLst>
                      <p:childTnLst>
                        <p:par>
                          <p:cTn id="64" fill="hold">
                            <p:stCondLst>
                              <p:cond delay="0"/>
                            </p:stCondLst>
                            <p:childTnLst>
                              <p:par>
                                <p:cTn id="6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7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9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1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1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e1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914400" y="27756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330033"/>
                </a:solidFill>
                <a:latin typeface="Baskerville Old Face"/>
              </a:rPr>
              <a:t>Conclusion</a:t>
            </a:r>
            <a:endParaRPr b="0" lang="en-US" sz="42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971640" y="1773360"/>
            <a:ext cx="7772400" cy="453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0000"/>
              </a:lnSpc>
              <a:spcBef>
                <a:spcPts val="700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Alpha coefficients and Pearson’s correlation has values that supports equivalence (GHQ-28 scales A and C were smaller than expected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spcBef>
                <a:spcPts val="700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Small mean differences between forms (SCL-90-R) could recommend to gather Internet normative data (Buchanan, 2003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spcBef>
                <a:spcPts val="700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Both factorial structure match recent research on these subject (e. g. Gibbons and Hilda, 2004; Schmitz et al., 2000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spd="slow">
    <p:pull dir="lu"/>
  </p:transition>
  <p:timing>
    <p:tnLst>
      <p:par>
        <p:cTn id="75" dur="indefinite" restart="never" nodeType="tmRoot">
          <p:childTnLst>
            <p:seq>
              <p:cTn id="76" dur="indefinite" nodeType="mainSeq">
                <p:childTnLst>
                  <p:par>
                    <p:cTn id="77" fill="hold">
                      <p:stCondLst>
                        <p:cond delay="indefinite"/>
                      </p:stCondLst>
                      <p:childTnLst>
                        <p:par>
                          <p:cTn id="78" fill="hold">
                            <p:stCondLst>
                              <p:cond delay="0"/>
                            </p:stCondLst>
                            <p:childTnLst>
                              <p:par>
                                <p:cTn id="7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1" fill="hold">
                      <p:stCondLst>
                        <p:cond delay="indefinite"/>
                      </p:stCondLst>
                      <p:childTnLst>
                        <p:par>
                          <p:cTn id="82" fill="hold">
                            <p:stCondLst>
                              <p:cond delay="0"/>
                            </p:stCondLst>
                            <p:childTnLst>
                              <p:par>
                                <p:cTn id="83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e1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914400" y="27756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330033"/>
                </a:solidFill>
                <a:latin typeface="Baskerville Old Face"/>
              </a:rPr>
              <a:t>Suggestions</a:t>
            </a:r>
            <a:endParaRPr b="0" lang="en-US" sz="42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135" name="PlaceHolder 2"/>
          <p:cNvSpPr>
            <a:spLocks noGrp="1"/>
          </p:cNvSpPr>
          <p:nvPr>
            <p:ph/>
          </p:nvPr>
        </p:nvSpPr>
        <p:spPr>
          <a:xfrm>
            <a:off x="971640" y="1773360"/>
            <a:ext cx="7772400" cy="453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0000"/>
              </a:lnSpc>
              <a:spcBef>
                <a:spcPts val="700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Study other samples (normal and clinical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spcBef>
                <a:spcPts val="700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Using a counterbalanced design: paper-internet and internet-paper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649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Baskerville Old Face"/>
              </a:rPr>
              <a:t>Recent study (Vallejo et al., in preparation) N=40, C scale of GHQ-28 lower scores in Internet, 3.5 vs. 7.83 (t=8.02, p&lt;.001), r=.48 (p&lt;.01) 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spcBef>
                <a:spcPts val="700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Cautions with the use of screening psychopathological questionnaires in the Interne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iming>
    <p:tnLst>
      <p:par>
        <p:cTn id="85" dur="indefinite" restart="never" nodeType="tmRoot">
          <p:childTnLst>
            <p:seq>
              <p:cTn id="86" dur="indefinite" nodeType="mainSeq">
                <p:childTnLst>
                  <p:par>
                    <p:cTn id="87" fill="hold">
                      <p:stCondLst>
                        <p:cond delay="indefinite"/>
                      </p:stCondLst>
                      <p:childTnLst>
                        <p:par>
                          <p:cTn id="88" fill="hold">
                            <p:stCondLst>
                              <p:cond delay="0"/>
                            </p:stCondLst>
                            <p:childTnLst>
                              <p:par>
                                <p:cTn id="8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3" fill="hold">
                      <p:stCondLst>
                        <p:cond delay="indefinite"/>
                      </p:stCondLst>
                      <p:childTnLst>
                        <p:par>
                          <p:cTn id="94" fill="hold">
                            <p:stCondLst>
                              <p:cond delay="0"/>
                            </p:stCondLst>
                            <p:childTnLst>
                              <p:par>
                                <p:cTn id="9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e1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1332000" y="3860280"/>
            <a:ext cx="6858000" cy="256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Thank you very much for your attention</a:t>
            </a:r>
            <a:br>
              <a:rPr sz="2400"/>
            </a:b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7" name="" descr=""/>
          <p:cNvPicPr/>
          <p:nvPr/>
        </p:nvPicPr>
        <p:blipFill>
          <a:blip r:embed="rId1"/>
          <a:stretch/>
        </p:blipFill>
        <p:spPr>
          <a:xfrm>
            <a:off x="7596360" y="836640"/>
            <a:ext cx="1116000" cy="1116000"/>
          </a:xfrm>
          <a:prstGeom prst="rect">
            <a:avLst/>
          </a:prstGeom>
          <a:ln w="0">
            <a:noFill/>
          </a:ln>
        </p:spPr>
      </p:pic>
      <p:pic>
        <p:nvPicPr>
          <p:cNvPr id="138" name="" descr=""/>
          <p:cNvPicPr/>
          <p:nvPr/>
        </p:nvPicPr>
        <p:blipFill>
          <a:blip r:embed="rId2"/>
          <a:stretch/>
        </p:blipFill>
        <p:spPr>
          <a:xfrm>
            <a:off x="4284720" y="907920"/>
            <a:ext cx="3174840" cy="2438640"/>
          </a:xfrm>
          <a:prstGeom prst="rect">
            <a:avLst/>
          </a:prstGeom>
          <a:ln w="0">
            <a:noFill/>
          </a:ln>
        </p:spPr>
      </p:pic>
      <p:pic>
        <p:nvPicPr>
          <p:cNvPr id="139" name="" descr=""/>
          <p:cNvPicPr/>
          <p:nvPr/>
        </p:nvPicPr>
        <p:blipFill>
          <a:blip r:embed="rId3"/>
          <a:stretch/>
        </p:blipFill>
        <p:spPr>
          <a:xfrm>
            <a:off x="611280" y="836640"/>
            <a:ext cx="1866960" cy="714240"/>
          </a:xfrm>
          <a:prstGeom prst="rect">
            <a:avLst/>
          </a:prstGeom>
          <a:ln w="0">
            <a:noFill/>
          </a:ln>
        </p:spPr>
      </p:pic>
      <p:sp>
        <p:nvSpPr>
          <p:cNvPr id="140" name=""/>
          <p:cNvSpPr/>
          <p:nvPr/>
        </p:nvSpPr>
        <p:spPr>
          <a:xfrm>
            <a:off x="1547640" y="189000"/>
            <a:ext cx="713124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37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2200" spc="-1" strike="noStrike">
                <a:solidFill>
                  <a:srgbClr val="5f5f5f"/>
                </a:solidFill>
                <a:latin typeface="Baskerville Old Face"/>
              </a:rPr>
              <a:t>Universidad Nacional de Educación a Distancia, SPAIN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spd="slow">
    <p:pull dir="lu"/>
  </p:transition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e1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914400" y="27756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330033"/>
                </a:solidFill>
                <a:latin typeface="Baskerville Old Face"/>
              </a:rPr>
              <a:t>Introduction</a:t>
            </a:r>
            <a:endParaRPr b="0" lang="en-US" sz="42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106" name="PlaceHolder 2"/>
          <p:cNvSpPr>
            <a:spLocks noGrp="1"/>
          </p:cNvSpPr>
          <p:nvPr>
            <p:ph/>
          </p:nvPr>
        </p:nvSpPr>
        <p:spPr>
          <a:xfrm>
            <a:off x="826920" y="1989000"/>
            <a:ext cx="7772400" cy="453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0000"/>
              </a:lnSpc>
              <a:spcBef>
                <a:spcPts val="700"/>
              </a:spcBef>
              <a:spcAft>
                <a:spcPts val="1800"/>
              </a:spcAft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Online assessment as a necessity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spcBef>
                <a:spcPts val="700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Some advantages: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649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Baskerville Old Face"/>
              </a:rPr>
              <a:t>Easy and immediate scoring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649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Baskerville Old Face"/>
              </a:rPr>
              <a:t>Missing data handling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spcBef>
                <a:spcPts val="1800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The question: Will the mode of administration (Internet) affect the psychometric characteristics of assessment tools?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spd="slow">
    <p:pull dir="lu"/>
  </p:transition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6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6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6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6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e1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914400" y="27756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330033"/>
                </a:solidFill>
                <a:latin typeface="Baskerville Old Face"/>
              </a:rPr>
              <a:t>The literature</a:t>
            </a:r>
            <a:endParaRPr b="0" lang="en-US" sz="42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108" name="PlaceHolder 2"/>
          <p:cNvSpPr>
            <a:spLocks noGrp="1"/>
          </p:cNvSpPr>
          <p:nvPr>
            <p:ph/>
          </p:nvPr>
        </p:nvSpPr>
        <p:spPr>
          <a:xfrm>
            <a:off x="826560" y="2060280"/>
            <a:ext cx="4032360" cy="326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8000"/>
          </a:bodyPr>
          <a:p>
            <a:pPr marL="301680" indent="-301680">
              <a:lnSpc>
                <a:spcPct val="90000"/>
              </a:lnSpc>
              <a:spcBef>
                <a:spcPts val="550"/>
              </a:spcBef>
              <a:spcAft>
                <a:spcPts val="1800"/>
              </a:spcAft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Baskerville Old Face"/>
              </a:rPr>
              <a:t>Proposed variables that  could affect Internet results: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1" marL="653760" indent="-251280">
              <a:lnSpc>
                <a:spcPct val="90000"/>
              </a:lnSpc>
              <a:spcBef>
                <a:spcPts val="550"/>
              </a:spcBef>
              <a:spcAft>
                <a:spcPts val="1800"/>
              </a:spcAft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Baskerville Old Face"/>
              </a:rPr>
              <a:t>Social desirability </a:t>
            </a:r>
            <a:r>
              <a:rPr b="0" lang="en-GB" sz="2200" spc="-1" strike="noStrike">
                <a:solidFill>
                  <a:srgbClr val="000000"/>
                </a:solidFill>
                <a:latin typeface="Baskerville Old Face"/>
              </a:rPr>
              <a:t>(Booth-Kewley, et al., in press)</a:t>
            </a:r>
            <a:r>
              <a:rPr b="0" lang="es-ES_tradnl" sz="2200" spc="-1" strike="noStrike">
                <a:solidFill>
                  <a:srgbClr val="000000"/>
                </a:solidFill>
                <a:latin typeface="Baskerville Old Face"/>
              </a:rPr>
              <a:t> 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1" marL="653760" indent="-251280">
              <a:lnSpc>
                <a:spcPct val="90000"/>
              </a:lnSpc>
              <a:spcBef>
                <a:spcPts val="550"/>
              </a:spcBef>
              <a:spcAft>
                <a:spcPts val="1800"/>
              </a:spcAft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Baskerville Old Face"/>
              </a:rPr>
              <a:t>Self-disclosure </a:t>
            </a:r>
            <a:r>
              <a:rPr b="0" lang="en-GB" sz="2200" spc="-1" strike="noStrike">
                <a:solidFill>
                  <a:srgbClr val="000000"/>
                </a:solidFill>
                <a:latin typeface="Baskerville Old Face"/>
              </a:rPr>
              <a:t>(Suler, 2004) 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1" marL="653760" indent="-251280">
              <a:lnSpc>
                <a:spcPct val="90000"/>
              </a:lnSpc>
              <a:spcBef>
                <a:spcPts val="550"/>
              </a:spcBef>
              <a:spcAft>
                <a:spcPts val="1800"/>
              </a:spcAft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Baskerville Old Face"/>
              </a:rPr>
              <a:t>Computer anxiety </a:t>
            </a:r>
            <a:r>
              <a:rPr b="0" lang="en-GB" sz="2200" spc="-1" strike="noStrike">
                <a:solidFill>
                  <a:srgbClr val="000000"/>
                </a:solidFill>
                <a:latin typeface="Baskerville Old Face"/>
              </a:rPr>
              <a:t>(Shulenberg and Yutrzenka, 2004) 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3"/>
          <p:cNvSpPr>
            <a:spLocks noGrp="1"/>
          </p:cNvSpPr>
          <p:nvPr>
            <p:ph/>
          </p:nvPr>
        </p:nvSpPr>
        <p:spPr>
          <a:xfrm>
            <a:off x="4858920" y="1989000"/>
            <a:ext cx="3809880" cy="4530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0000"/>
          </a:bodyPr>
          <a:p>
            <a:pPr marL="308520" indent="-308520">
              <a:lnSpc>
                <a:spcPct val="100000"/>
              </a:lnSpc>
              <a:spcBef>
                <a:spcPts val="550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Baskerville Old Face"/>
              </a:rPr>
              <a:t>Different subjects in which literature exists: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1" marL="668520" indent="-257040">
              <a:lnSpc>
                <a:spcPct val="100000"/>
              </a:lnSpc>
              <a:spcBef>
                <a:spcPts val="550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Baskerville Old Face"/>
              </a:rPr>
              <a:t>Panic/agoraphobia (Carlbring et al., in press)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1" marL="668520" indent="-257040">
              <a:lnSpc>
                <a:spcPct val="100000"/>
              </a:lnSpc>
              <a:spcBef>
                <a:spcPts val="550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Baskerville Old Face"/>
              </a:rPr>
              <a:t>Youth independent living (Bressani and Downs, 2002)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1" marL="668520" indent="-257040">
              <a:lnSpc>
                <a:spcPct val="100000"/>
              </a:lnSpc>
              <a:spcBef>
                <a:spcPts val="550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Baskerville Old Face"/>
              </a:rPr>
              <a:t>Agression and impulsivity (Suris et al., in press)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 lvl="1" marL="668520" indent="-257040">
              <a:lnSpc>
                <a:spcPct val="100000"/>
              </a:lnSpc>
              <a:spcBef>
                <a:spcPts val="550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Baskerville Old Face"/>
              </a:rPr>
              <a:t>Quality of life in diabetes (Pouwer et al., 1998)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spd="slow">
    <p:pull dir="lu"/>
  </p:transition>
  <p:timing>
    <p:tnLst>
      <p:par>
        <p:cTn id="15" dur="indefinite" restart="never" nodeType="tmRoot">
          <p:childTnLst>
            <p:seq>
              <p:cTn id="16" dur="indefinite" nodeType="mainSeq"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8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8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8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e1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title"/>
          </p:nvPr>
        </p:nvSpPr>
        <p:spPr>
          <a:xfrm>
            <a:off x="914400" y="27756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330033"/>
                </a:solidFill>
                <a:latin typeface="Baskerville Old Face"/>
              </a:rPr>
              <a:t>Our work: The Method</a:t>
            </a:r>
            <a:endParaRPr b="0" lang="en-US" sz="42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111" name="PlaceHolder 2"/>
          <p:cNvSpPr>
            <a:spLocks noGrp="1"/>
          </p:cNvSpPr>
          <p:nvPr>
            <p:ph/>
          </p:nvPr>
        </p:nvSpPr>
        <p:spPr>
          <a:xfrm>
            <a:off x="826920" y="2133720"/>
            <a:ext cx="3810240" cy="273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6000"/>
          </a:bodyPr>
          <a:p>
            <a:pPr marL="329040" indent="-329040">
              <a:lnSpc>
                <a:spcPct val="100000"/>
              </a:lnSpc>
              <a:spcBef>
                <a:spcPts val="700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The questionnaire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13160" indent="-274320">
              <a:lnSpc>
                <a:spcPct val="100000"/>
              </a:lnSpc>
              <a:spcBef>
                <a:spcPts val="700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GHQ-28 (Goldberg and Hillier, 1979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13160" indent="-274320">
              <a:lnSpc>
                <a:spcPct val="100000"/>
              </a:lnSpc>
              <a:spcBef>
                <a:spcPts val="700"/>
              </a:spcBef>
              <a:spcAft>
                <a:spcPts val="1800"/>
              </a:spcAft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SCL-90-R (Derogatis, 1977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4932360" y="2205000"/>
            <a:ext cx="3672000" cy="302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8000"/>
          </a:bodyPr>
          <a:p>
            <a:pPr marL="335880" indent="-335880">
              <a:lnSpc>
                <a:spcPct val="60000"/>
              </a:lnSpc>
              <a:spcBef>
                <a:spcPts val="3251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Baskerville Old Face"/>
              </a:rPr>
              <a:t>N=100, psychology</a:t>
            </a:r>
            <a:br>
              <a:rPr sz="2600"/>
            </a:br>
            <a:r>
              <a:rPr b="0" lang="en-US" sz="2600" spc="-1" strike="noStrike">
                <a:solidFill>
                  <a:srgbClr val="000000"/>
                </a:solidFill>
                <a:latin typeface="Baskerville Old Face"/>
              </a:rPr>
              <a:t>             students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marL="335880" indent="-335880">
              <a:lnSpc>
                <a:spcPct val="6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Women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78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35880" indent="-335880">
              <a:lnSpc>
                <a:spcPct val="6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Men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2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35880" indent="-335880">
              <a:lnSpc>
                <a:spcPct val="60000"/>
              </a:lnSpc>
              <a:spcBef>
                <a:spcPts val="649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Baskerville Old Face"/>
              </a:rPr>
              <a:t>Age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  <a:p>
            <a:pPr marL="335880" indent="-335880">
              <a:lnSpc>
                <a:spcPct val="6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Mean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27.4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35880" indent="-335880">
              <a:lnSpc>
                <a:spcPct val="6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SD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10.0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35880" indent="-335880">
              <a:lnSpc>
                <a:spcPct val="6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Unmarried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83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35880" indent="-335880">
              <a:lnSpc>
                <a:spcPct val="6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Married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	</a:t>
            </a:r>
            <a:r>
              <a:rPr b="0" lang="en-US" sz="2400" spc="-1" strike="noStrike">
                <a:solidFill>
                  <a:srgbClr val="000000"/>
                </a:solidFill>
                <a:latin typeface="Baskerville Old Face"/>
              </a:rPr>
              <a:t>17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spd="slow">
    <p:pull dir="lu"/>
  </p:transition>
  <p:timing>
    <p:tnLst>
      <p:par>
        <p:cTn id="37" dur="indefinite" restart="never" nodeType="tmRoot">
          <p:childTnLst>
            <p:seq>
              <p:cTn id="38" dur="indefinite" nodeType="mainSeq">
                <p:childTnLst>
                  <p:par>
                    <p:cTn id="39" fill="hold">
                      <p:stCondLst>
                        <p:cond delay="0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1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5" fill="hold">
                      <p:stCondLst>
                        <p:cond delay="indefinite"/>
                      </p:stCondLst>
                      <p:childTnLst>
                        <p:par>
                          <p:cTn id="46" fill="hold">
                            <p:stCondLst>
                              <p:cond delay="0"/>
                            </p:stCondLst>
                            <p:childTnLst>
                              <p:par>
                                <p:cTn id="47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e1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title"/>
          </p:nvPr>
        </p:nvSpPr>
        <p:spPr>
          <a:xfrm>
            <a:off x="914400" y="27756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330033"/>
                </a:solidFill>
                <a:latin typeface="Baskerville Old Face"/>
              </a:rPr>
              <a:t>Our work: The Procedure</a:t>
            </a:r>
            <a:endParaRPr b="0" lang="en-US" sz="4200" spc="-1" strike="noStrike">
              <a:solidFill>
                <a:srgbClr val="330033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1547640" y="1844640"/>
            <a:ext cx="6120000" cy="453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marL="343080" indent="-343080">
              <a:lnSpc>
                <a:spcPct val="100000"/>
              </a:lnSpc>
              <a:spcBef>
                <a:spcPts val="700"/>
              </a:spcBef>
              <a:buClr>
                <a:srgbClr val="b2b2b2"/>
              </a:buClr>
              <a:buSzPct val="9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Paper-pencil →Interne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700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Test: Paper and penci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700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Gap: Median = 17 day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700"/>
              </a:spcBef>
              <a:buClr>
                <a:srgbClr val="cccc99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Baskerville Old Face"/>
              </a:rPr>
              <a:t>Retest: Interne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100000"/>
              </a:lnSpc>
              <a:spcBef>
                <a:spcPts val="700"/>
              </a:spcBef>
              <a:buClr>
                <a:srgbClr val="b2b2b2"/>
              </a:buClr>
              <a:buSzPct val="55000"/>
              <a:buFont typeface="Wingdings" charset="2"/>
              <a:buChar char="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_tradnl" sz="2800" spc="-1" strike="noStrike">
                <a:solidFill>
                  <a:srgbClr val="000000"/>
                </a:solidFill>
                <a:latin typeface="Baskerville Old Face"/>
              </a:rPr>
              <a:t>Scroll-page &amp; spread box-tex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ransition spd="slow">
    <p:pull dir="lu"/>
  </p:transition>
  <p:timing>
    <p:tnLst>
      <p:par>
        <p:cTn id="49" dur="indefinite" restart="never" nodeType="tmRoot">
          <p:childTnLst>
            <p:seq>
              <p:cTn id="50" dur="indefinite" nodeType="mainSeq">
                <p:childTnLst>
                  <p:par>
                    <p:cTn id="51" fill="hold">
                      <p:stCondLst>
                        <p:cond delay="0"/>
                      </p:stCondLst>
                      <p:childTnLst>
                        <p:par>
                          <p:cTn id="52" fill="hold">
                            <p:stCondLst>
                              <p:cond delay="0"/>
                            </p:stCondLst>
                            <p:childTnLst>
                              <p:par>
                                <p:cTn id="5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4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5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4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7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4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9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4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e1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PlaceHolder 1"/>
          <p:cNvSpPr>
            <a:spLocks noGrp="1"/>
          </p:cNvSpPr>
          <p:nvPr>
            <p:ph type="title"/>
          </p:nvPr>
        </p:nvSpPr>
        <p:spPr>
          <a:xfrm>
            <a:off x="914400" y="27756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330033"/>
                </a:solidFill>
                <a:latin typeface="Baskerville Old Face"/>
              </a:rPr>
              <a:t>GHQ-28 reliability</a:t>
            </a:r>
            <a:endParaRPr b="0" lang="en-US" sz="4200" spc="-1" strike="noStrike">
              <a:solidFill>
                <a:srgbClr val="330033"/>
              </a:solidFill>
              <a:latin typeface="Times New Roman"/>
            </a:endParaRPr>
          </a:p>
        </p:txBody>
      </p:sp>
      <p:graphicFrame>
        <p:nvGraphicFramePr>
          <p:cNvPr id="116" name=""/>
          <p:cNvGraphicFramePr/>
          <p:nvPr/>
        </p:nvGraphicFramePr>
        <p:xfrm>
          <a:off x="179280" y="2060640"/>
          <a:ext cx="9385560" cy="700236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117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9280" y="2060640"/>
                    <a:ext cx="9385560" cy="7002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p:transition spd="slow">
    <p:pull dir="lu"/>
  </p:transition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e1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PlaceHolder 1"/>
          <p:cNvSpPr>
            <a:spLocks noGrp="1"/>
          </p:cNvSpPr>
          <p:nvPr>
            <p:ph type="title"/>
          </p:nvPr>
        </p:nvSpPr>
        <p:spPr>
          <a:xfrm>
            <a:off x="914400" y="27756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330033"/>
                </a:solidFill>
                <a:latin typeface="Baskerville Old Face"/>
              </a:rPr>
              <a:t>GHQ-28 factorial structure</a:t>
            </a:r>
            <a:endParaRPr b="0" lang="en-US" sz="4200" spc="-1" strike="noStrike">
              <a:solidFill>
                <a:srgbClr val="330033"/>
              </a:solidFill>
              <a:latin typeface="Times New Roman"/>
            </a:endParaRPr>
          </a:p>
        </p:txBody>
      </p:sp>
      <p:graphicFrame>
        <p:nvGraphicFramePr>
          <p:cNvPr id="119" name=""/>
          <p:cNvGraphicFramePr/>
          <p:nvPr/>
        </p:nvGraphicFramePr>
        <p:xfrm>
          <a:off x="695160" y="903240"/>
          <a:ext cx="8120160" cy="471348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120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95160" y="903240"/>
                    <a:ext cx="8120160" cy="4713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p:transition spd="slow">
    <p:pull dir="lu"/>
  </p:transition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e1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laceHolder 1"/>
          <p:cNvSpPr>
            <a:spLocks noGrp="1"/>
          </p:cNvSpPr>
          <p:nvPr>
            <p:ph type="title"/>
          </p:nvPr>
        </p:nvSpPr>
        <p:spPr>
          <a:xfrm>
            <a:off x="914400" y="27756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330033"/>
                </a:solidFill>
                <a:latin typeface="Baskerville Old Face"/>
              </a:rPr>
              <a:t>GHQ-28 factorial structure</a:t>
            </a:r>
            <a:endParaRPr b="0" lang="en-US" sz="4200" spc="-1" strike="noStrike">
              <a:solidFill>
                <a:srgbClr val="330033"/>
              </a:solidFill>
              <a:latin typeface="Times New Roman"/>
            </a:endParaRPr>
          </a:p>
        </p:txBody>
      </p:sp>
      <p:graphicFrame>
        <p:nvGraphicFramePr>
          <p:cNvPr id="122" name=""/>
          <p:cNvGraphicFramePr/>
          <p:nvPr/>
        </p:nvGraphicFramePr>
        <p:xfrm>
          <a:off x="708120" y="903240"/>
          <a:ext cx="8024760" cy="467856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12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08120" y="903240"/>
                    <a:ext cx="8024760" cy="4678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p:transition spd="slow">
    <p:pull dir="lu"/>
  </p:transition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e1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914400" y="27756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330033"/>
                </a:solidFill>
                <a:latin typeface="Baskerville Old Face"/>
              </a:rPr>
              <a:t>SCL-90-R reliability</a:t>
            </a:r>
            <a:endParaRPr b="0" lang="en-US" sz="4200" spc="-1" strike="noStrike">
              <a:solidFill>
                <a:srgbClr val="330033"/>
              </a:solidFill>
              <a:latin typeface="Times New Roman"/>
            </a:endParaRPr>
          </a:p>
        </p:txBody>
      </p:sp>
      <p:graphicFrame>
        <p:nvGraphicFramePr>
          <p:cNvPr id="125" name=""/>
          <p:cNvGraphicFramePr/>
          <p:nvPr/>
        </p:nvGraphicFramePr>
        <p:xfrm>
          <a:off x="241200" y="765000"/>
          <a:ext cx="8902800" cy="841392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126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41200" y="765000"/>
                    <a:ext cx="8902800" cy="8413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p:transition spd="slow">
    <p:pull dir="lu"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3-02T15:53:46Z</dcterms:created>
  <dc:creator>Carlos</dc:creator>
  <dc:description/>
  <dc:language>en-US</dc:language>
  <cp:lastModifiedBy>MAV</cp:lastModifiedBy>
  <dcterms:modified xsi:type="dcterms:W3CDTF">2006-05-10T08:47:40Z</dcterms:modified>
  <cp:revision>35</cp:revision>
  <dc:subject/>
  <dc:title>Psychological assessment through the Internet</dc:title>
</cp:coreProperties>
</file>